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388584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head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108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ar-SA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ar-SA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r" rtl="1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388584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108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0462408-895E-48FB-AB46-6C8CCDDDF55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54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rtl="1">
              <a:lnSpc>
                <a:spcPct val="100000"/>
              </a:lnSpc>
              <a:spcBef>
                <a:spcPts val="187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.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alysis of the </a:t>
            </a: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TP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. The chromatogram shows the partial sequence of exon 18 in the proband II.1 (family E). In above, the normal </a:t>
            </a: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TP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séquence (reference NM_000253). In the below, mutant sequence show the homozygous state of the novel nucleotide deletion (c. 2611delC) and the frameshift in the mRNA. The predicted translation product of the mutant </a:t>
            </a:r>
            <a:r>
              <a:rPr b="0" i="1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TP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is a non functional protein of 898 amino acids (p.H871I fsX29) lacking the last 23 functional amino acids</a:t>
            </a:r>
            <a:r>
              <a:rPr b="0" lang="en-US" sz="5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  <a:p>
            <a:pPr indent="0" rtl="1">
              <a:lnSpc>
                <a:spcPct val="100000"/>
              </a:lnSpc>
              <a:spcBef>
                <a:spcPts val="187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2DCBDC-035A-4B82-84CB-4813F9B593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B04F53-63AA-4CA2-8D76-716E67F003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16AE30-0305-4B95-B1A0-B1E87B11D12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D10518-0B54-4640-9275-8693F9C05D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905976-997A-4EA7-A128-3E78BFF67E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FBF090-2469-4724-971A-A4CC225BCE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A33118-6CA6-45B4-8B07-3181D7030A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D2B415-5064-4998-AEFE-B3E8EB3426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72DA6A-A44D-4D3A-90CC-8622ECA676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41BA1C-6D5E-4642-A55A-10D2D2A5C4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D25E00-FE7B-4643-A7DC-E72F37A208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BC322C-E1D6-4DA4-84A3-800A8BE2B7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50AE09-10EF-4FEA-9DDC-92776C42204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394920" y="2781000"/>
            <a:ext cx="10945800" cy="576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rtl="1">
              <a:lnSpc>
                <a:spcPct val="10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utant sequenc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…CCG    CTC    ATC     AAG  AGA  ACT   CAG AGA TGT   GCA… …  ACT  GAC CTG   TG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23720" y="1116000"/>
            <a:ext cx="9433080" cy="936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 rtl="1">
              <a:lnSpc>
                <a:spcPct val="10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ference sequenc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…CCG  CT</a:t>
            </a:r>
            <a:r>
              <a:rPr b="1" i="1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CAT     CCA  GAG  AAC  TCA  GAG  ATG…</a:t>
            </a:r>
            <a:r>
              <a:rPr b="0" lang="en-US" sz="1200" spc="-1" strike="noStrike">
                <a:solidFill>
                  <a:srgbClr val="ff6600"/>
                </a:solidFill>
                <a:latin typeface="Times New Roman"/>
                <a:ea typeface="Times New Roman"/>
              </a:rPr>
              <a:t> …….TG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                    …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    Leu     His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7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Gln    Glu    Asn    Ser     Glu    Met…  ……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OP</a:t>
            </a:r>
            <a:r>
              <a:rPr b="1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9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1692360" y="1844640"/>
            <a:ext cx="3887640" cy="122400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1547640" y="2997360"/>
            <a:ext cx="10946160" cy="57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rtl="1">
              <a:lnSpc>
                <a:spcPct val="10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spcBef>
                <a:spcPts val="2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…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    Leu     Ile </a:t>
            </a:r>
            <a:r>
              <a:rPr b="1" i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7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Lys    Arg    Thr     Gln    Arg     Cys   Ala… …     Thr   Asp   Leu    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TOP </a:t>
            </a:r>
            <a:r>
              <a:rPr b="1" i="1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0" y="3860640"/>
            <a:ext cx="9144000" cy="1584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 rtl="1">
              <a:lnSpc>
                <a:spcPct val="100000"/>
              </a:lnSpc>
              <a:spcBef>
                <a:spcPts val="3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	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rtl="1">
              <a:lnSpc>
                <a:spcPct val="100000"/>
              </a:lnSpc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1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alysis of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T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. The chromatogram show the partial sequence of exon 18 in the proband II.1 (family E). In above, the normal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T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sequence (reference NM_000253). In the below, mutant sequence show the homozygous state of the novel nucleotide deletion (c. 2611delC) and the frameshift in the mRNA. The predicted translation product of the mutant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TTP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gene is a non functional protein of 898 amino acids (p.H871I fsX29) lacking the last 23 functional amino-acids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16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26T06:46:17Z</dcterms:created>
  <dc:creator>Mohamed</dc:creator>
  <dc:description/>
  <dc:language>en-US</dc:language>
  <cp:lastModifiedBy>Mohamed</cp:lastModifiedBy>
  <dcterms:modified xsi:type="dcterms:W3CDTF">2013-01-11T05:15:00Z</dcterms:modified>
  <cp:revision>6</cp:revision>
  <dc:subject/>
  <dc:title>Diapositive 1</dc:title>
</cp:coreProperties>
</file>